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63" r:id="rId2"/>
    <p:sldId id="257" r:id="rId3"/>
    <p:sldId id="258" r:id="rId4"/>
    <p:sldId id="259" r:id="rId5"/>
    <p:sldId id="260" r:id="rId6"/>
    <p:sldId id="261" r:id="rId7"/>
    <p:sldId id="262" r:id="rId8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99" d="100"/>
          <a:sy n="99" d="100"/>
        </p:scale>
        <p:origin x="-240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0ABFD24-27B4-47D8-B2BE-C7562EB6C4F4}" type="datetimeFigureOut">
              <a:rPr lang="en-US" smtClean="0"/>
              <a:t>8/10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638FF0F-DD7E-4E3A-8719-3C377C4A7D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27036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A106589-09E4-4B02-9B4F-B39CBBDF9DB3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045837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, MAV  B, MAB</a:t>
            </a:r>
          </a:p>
          <a:p>
            <a:pPr defTabSz="914318">
              <a:defRPr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ctual growth measured by CFU plating or 3H-uridine incorporation assay for experiments shown in Fig 3B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A106589-09E4-4B02-9B4F-B39CBBDF9DB3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608599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A106589-09E4-4B02-9B4F-B39CBBDF9DB3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32828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F37BBE-5E50-4D04-96CD-7730C3B1E0F8}" type="datetimeFigureOut">
              <a:rPr lang="en-US" smtClean="0"/>
              <a:t>8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FF143-EBD6-437D-8357-A3190C587E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34677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F37BBE-5E50-4D04-96CD-7730C3B1E0F8}" type="datetimeFigureOut">
              <a:rPr lang="en-US" smtClean="0"/>
              <a:t>8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FF143-EBD6-437D-8357-A3190C587E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06318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F37BBE-5E50-4D04-96CD-7730C3B1E0F8}" type="datetimeFigureOut">
              <a:rPr lang="en-US" smtClean="0"/>
              <a:t>8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FF143-EBD6-437D-8357-A3190C587E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14018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F37BBE-5E50-4D04-96CD-7730C3B1E0F8}" type="datetimeFigureOut">
              <a:rPr lang="en-US" smtClean="0"/>
              <a:t>8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FF143-EBD6-437D-8357-A3190C587E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67434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F37BBE-5E50-4D04-96CD-7730C3B1E0F8}" type="datetimeFigureOut">
              <a:rPr lang="en-US" smtClean="0"/>
              <a:t>8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FF143-EBD6-437D-8357-A3190C587E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4666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F37BBE-5E50-4D04-96CD-7730C3B1E0F8}" type="datetimeFigureOut">
              <a:rPr lang="en-US" smtClean="0"/>
              <a:t>8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FF143-EBD6-437D-8357-A3190C587E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17886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F37BBE-5E50-4D04-96CD-7730C3B1E0F8}" type="datetimeFigureOut">
              <a:rPr lang="en-US" smtClean="0"/>
              <a:t>8/10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FF143-EBD6-437D-8357-A3190C587E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13761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F37BBE-5E50-4D04-96CD-7730C3B1E0F8}" type="datetimeFigureOut">
              <a:rPr lang="en-US" smtClean="0"/>
              <a:t>8/10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FF143-EBD6-437D-8357-A3190C587E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32922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F37BBE-5E50-4D04-96CD-7730C3B1E0F8}" type="datetimeFigureOut">
              <a:rPr lang="en-US" smtClean="0"/>
              <a:t>8/10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FF143-EBD6-437D-8357-A3190C587E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52324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F37BBE-5E50-4D04-96CD-7730C3B1E0F8}" type="datetimeFigureOut">
              <a:rPr lang="en-US" smtClean="0"/>
              <a:t>8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FF143-EBD6-437D-8357-A3190C587E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01091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F37BBE-5E50-4D04-96CD-7730C3B1E0F8}" type="datetimeFigureOut">
              <a:rPr lang="en-US" smtClean="0"/>
              <a:t>8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AFF143-EBD6-437D-8357-A3190C587E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41696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F37BBE-5E50-4D04-96CD-7730C3B1E0F8}" type="datetimeFigureOut">
              <a:rPr lang="en-US" smtClean="0"/>
              <a:t>8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AFF143-EBD6-437D-8357-A3190C587E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43942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6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43400" y="3281363"/>
            <a:ext cx="455613" cy="295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" y="1828800"/>
            <a:ext cx="9228138" cy="2482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Rectangle 1"/>
          <p:cNvSpPr/>
          <p:nvPr/>
        </p:nvSpPr>
        <p:spPr>
          <a:xfrm>
            <a:off x="457200" y="4267200"/>
            <a:ext cx="86106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1. Stimulation of PPD-positive PBMC with MAV leads to significant expansion of CD4 and CD8 T cells. Experiment in Figure 1 was repeated using PBMC from additional PPD-positive volunteers (n=5). Experimental condition was similar to Figure 1 except that CFSE-labeled PBMC were stimulated with either BCG, MAV WL, MAB WL o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t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PD. Medium rested (MR) PBMC were used as negative controls. (A) Percent proliferated T cells after stimulation with different antigens. There was significant expansion of CD4 (B) and CD8 (C) T cells with all the antigens except MAB WL (P &lt;0.05, Mann Whitney U test). </a:t>
            </a:r>
          </a:p>
        </p:txBody>
      </p:sp>
    </p:spTree>
    <p:extLst>
      <p:ext uri="{BB962C8B-B14F-4D97-AF65-F5344CB8AC3E}">
        <p14:creationId xmlns:p14="http://schemas.microsoft.com/office/powerpoint/2010/main" val="38062528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507"/>
          <a:stretch/>
        </p:blipFill>
        <p:spPr bwMode="auto">
          <a:xfrm>
            <a:off x="183682" y="381000"/>
            <a:ext cx="8724900" cy="43342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Rectangle 1"/>
          <p:cNvSpPr/>
          <p:nvPr/>
        </p:nvSpPr>
        <p:spPr>
          <a:xfrm>
            <a:off x="457200" y="4800600"/>
            <a:ext cx="830580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2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C and MAB cross-reactive immunity includes Th1 and Th17 responses. (A) Schematic of experiments conducted to measure MAV or MAB cross-reactive immunity. PBMC from BCG-vaccinated or LTBI individuals were stimulated with BCG or rested in media for 7 days. Then, these cells were co-cultured with MAV- or MAB-infected autologous monocytes at E:T ratio of 10:1. On day 3 of co-culture, Th1, Th2 and Th17 responses were measured in supernatants using CBA. (B) Exposure of BCG-expanded T cells to MAC-infected macrophages significantly increase in Th17 (P=0.02), IFN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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P=0.03) and TNF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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P= 0.03), and decrease IL-10 (P= 0.02). (C) Exposure of BCG-expanded T cells to MAB-infected macrophages significantly increased IL-17 and IFN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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he supernatants (P= 0.03, n=6). *P &lt;0.05, Wilcoxon match-paired test.</a:t>
            </a:r>
          </a:p>
        </p:txBody>
      </p:sp>
    </p:spTree>
    <p:extLst>
      <p:ext uri="{BB962C8B-B14F-4D97-AF65-F5344CB8AC3E}">
        <p14:creationId xmlns:p14="http://schemas.microsoft.com/office/powerpoint/2010/main" val="35156655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3400" y="838200"/>
            <a:ext cx="8229600" cy="33873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Rectangle 1"/>
          <p:cNvSpPr/>
          <p:nvPr/>
        </p:nvSpPr>
        <p:spPr>
          <a:xfrm>
            <a:off x="762000" y="4383930"/>
            <a:ext cx="80010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3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V and MAB replicates well inside human macrophages. Human monocytes from different volunteers (n=3) were infected in triplicates at different multiplicities of infection (MOI) overnight with MAV (ATCC 700898) or for 4h with MAB (NR-44261, BEI Resources). Following infection, extracellular mycobacteria were washed away, and at different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imepoint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acrophages were lysed and released mycobacteria quantified by culturing in 7H10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ddlebrook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gar as described previously (24). MAV (A) and MAB (B) replicate inside macrophages making them amenable to T cell effector functions.</a:t>
            </a:r>
          </a:p>
        </p:txBody>
      </p:sp>
    </p:spTree>
    <p:extLst>
      <p:ext uri="{BB962C8B-B14F-4D97-AF65-F5344CB8AC3E}">
        <p14:creationId xmlns:p14="http://schemas.microsoft.com/office/powerpoint/2010/main" val="211454162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3183" y="990600"/>
            <a:ext cx="8229600" cy="307435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Rectangle 1"/>
          <p:cNvSpPr/>
          <p:nvPr/>
        </p:nvSpPr>
        <p:spPr>
          <a:xfrm>
            <a:off x="1108508" y="4078593"/>
            <a:ext cx="7689783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ample of FACS plot showing purity of subsets of T cells used in the mycobacterial inhibition assays. Subsets of T cells were purified from BCG stimulated PBMC. CD4 and CD8 T cells were 96% pure an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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 were 98% pure.</a:t>
            </a:r>
          </a:p>
        </p:txBody>
      </p:sp>
    </p:spTree>
    <p:extLst>
      <p:ext uri="{BB962C8B-B14F-4D97-AF65-F5344CB8AC3E}">
        <p14:creationId xmlns:p14="http://schemas.microsoft.com/office/powerpoint/2010/main" val="19704864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600" y="685800"/>
            <a:ext cx="7777163" cy="29384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Rectangle 1"/>
          <p:cNvSpPr/>
          <p:nvPr/>
        </p:nvSpPr>
        <p:spPr>
          <a:xfrm>
            <a:off x="1219200" y="3639234"/>
            <a:ext cx="70104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5. 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FU counts or CPM values for mycobacterial growth inhibition assays shown in Figures 3B and 3C. 3H-Uridine incorporation to quantify the number of MAV and CFU count was used for MAB. 3H-urindine incorporation, a rapid assay, was used for MAV because MAV is slow growing.</a:t>
            </a:r>
          </a:p>
        </p:txBody>
      </p:sp>
    </p:spTree>
    <p:extLst>
      <p:ext uri="{BB962C8B-B14F-4D97-AF65-F5344CB8AC3E}">
        <p14:creationId xmlns:p14="http://schemas.microsoft.com/office/powerpoint/2010/main" val="358525810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90800" y="1828800"/>
            <a:ext cx="3757613" cy="24257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Rectangle 1"/>
          <p:cNvSpPr/>
          <p:nvPr/>
        </p:nvSpPr>
        <p:spPr>
          <a:xfrm>
            <a:off x="2577966" y="4227797"/>
            <a:ext cx="63246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6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CFSE low population for experiments in Figure 6. </a:t>
            </a:r>
          </a:p>
        </p:txBody>
      </p:sp>
    </p:spTree>
    <p:extLst>
      <p:ext uri="{BB962C8B-B14F-4D97-AF65-F5344CB8AC3E}">
        <p14:creationId xmlns:p14="http://schemas.microsoft.com/office/powerpoint/2010/main" val="171634415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410"/>
          <a:stretch/>
        </p:blipFill>
        <p:spPr bwMode="auto">
          <a:xfrm>
            <a:off x="1905000" y="1981200"/>
            <a:ext cx="5315552" cy="23938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Rectangle 1"/>
          <p:cNvSpPr/>
          <p:nvPr/>
        </p:nvSpPr>
        <p:spPr>
          <a:xfrm>
            <a:off x="2276776" y="4375089"/>
            <a:ext cx="557182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7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ypical FACS plot showing flow cytometric gating for CFSE an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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CR</a:t>
            </a:r>
          </a:p>
        </p:txBody>
      </p:sp>
    </p:spTree>
    <p:extLst>
      <p:ext uri="{BB962C8B-B14F-4D97-AF65-F5344CB8AC3E}">
        <p14:creationId xmlns:p14="http://schemas.microsoft.com/office/powerpoint/2010/main" val="21533633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546</Words>
  <Application>Microsoft Office PowerPoint</Application>
  <PresentationFormat>On-screen Show (4:3)</PresentationFormat>
  <Paragraphs>12</Paragraphs>
  <Slides>7</Slides>
  <Notes>3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Saint Louis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tahun Abate</dc:creator>
  <cp:lastModifiedBy>Getahun Abate</cp:lastModifiedBy>
  <cp:revision>3</cp:revision>
  <dcterms:created xsi:type="dcterms:W3CDTF">2018-07-14T20:16:44Z</dcterms:created>
  <dcterms:modified xsi:type="dcterms:W3CDTF">2018-08-10T19:17:43Z</dcterms:modified>
</cp:coreProperties>
</file>